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-636" y="-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252B088B-F7B8-4512-8AFA-11E92A62C2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9A9C1409-9220-49F3-B590-DB3EE7C932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B7BC308-168C-4FCA-98B4-82B8C055C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D50-781E-4BD3-9232-6C9BC43C6BC1}" type="datetimeFigureOut">
              <a:rPr lang="zh-CN" altLang="en-US" smtClean="0"/>
              <a:t>2021/10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2BF7E4EF-439E-4814-8CCF-1CA3E66D2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F65B0070-74E7-4B4A-935E-4CE66763A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EA5D9-C73A-4035-87D2-EE4D85F732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4481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709D082-7116-474C-A575-0F10CFB114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7D626144-0CE2-433C-B307-72B267C30E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FD4AC030-6BC7-4A04-870E-EE526EB81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D50-781E-4BD3-9232-6C9BC43C6BC1}" type="datetimeFigureOut">
              <a:rPr lang="zh-CN" altLang="en-US" smtClean="0"/>
              <a:t>2021/10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F614685E-CDBD-48DB-8000-7D869B618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3B1014D7-00E3-4809-BCDE-338707333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EA5D9-C73A-4035-87D2-EE4D85F732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3747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F92B361E-2930-4453-9B4F-D720288C83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7A819A65-A618-417E-9078-EB3E87CE59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0FD90AED-720B-456C-B8BB-2152C482C9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D50-781E-4BD3-9232-6C9BC43C6BC1}" type="datetimeFigureOut">
              <a:rPr lang="zh-CN" altLang="en-US" smtClean="0"/>
              <a:t>2021/10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155901D3-3370-405E-BC8F-1515EF134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1AA21DD-27EE-452C-ADE1-E4B1C0D3D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EA5D9-C73A-4035-87D2-EE4D85F732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6858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6548442-2029-4A03-AD3B-BA112861B3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33B6F92-E44C-4479-8151-1323D6362C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D35830C3-AD7A-4D35-996D-1B7AC4467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D50-781E-4BD3-9232-6C9BC43C6BC1}" type="datetimeFigureOut">
              <a:rPr lang="zh-CN" altLang="en-US" smtClean="0"/>
              <a:t>2021/10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144936BF-495B-480A-B013-8B7EA4341A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CEABBB1-2178-4827-940B-4432D79F72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EA5D9-C73A-4035-87D2-EE4D85F732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9800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AD6EB54-6ED0-43D9-A65A-4DB079BB60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119D46C-DEE7-4952-AC0D-B2E1AE7061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58B50F3-5596-4464-9CE8-0BB32A294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D50-781E-4BD3-9232-6C9BC43C6BC1}" type="datetimeFigureOut">
              <a:rPr lang="zh-CN" altLang="en-US" smtClean="0"/>
              <a:t>2021/10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63B526C-1A98-4E2A-B5AF-FFE59DD87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967F49A-F935-4F31-9E3B-052CEB8ADE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EA5D9-C73A-4035-87D2-EE4D85F732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0336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334367B-5203-4974-8BB7-682B6502BE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34E608B-BB6E-4B53-A8E2-3A0D2FC96C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25853A2D-B894-4716-ADBE-7B76181A6A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B231ACBF-FD75-45D8-BD57-F6292380B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D50-781E-4BD3-9232-6C9BC43C6BC1}" type="datetimeFigureOut">
              <a:rPr lang="zh-CN" altLang="en-US" smtClean="0"/>
              <a:t>2021/10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55F471CB-C589-431D-BA2F-84FBEAC09C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796F92B8-AFEC-4459-88A2-D5C4C1501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EA5D9-C73A-4035-87D2-EE4D85F732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9674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30EF172-8415-4D9E-811F-E517E4E3E6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069A1DE9-F99B-473A-9A75-A0771F9B91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A8B6003F-23CE-4690-8958-8B601814BD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14CB6B80-5021-484E-A4E5-9ECE08C466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9601ABDD-77C9-406D-B2EE-356384C08E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AE1931BA-54CB-45D1-B566-95EC20BFE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D50-781E-4BD3-9232-6C9BC43C6BC1}" type="datetimeFigureOut">
              <a:rPr lang="zh-CN" altLang="en-US" smtClean="0"/>
              <a:t>2021/10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5D9B8393-6F4C-4FF0-A71C-8FB3D4850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92D11D43-19CF-42D5-8EA5-885B685DE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EA5D9-C73A-4035-87D2-EE4D85F732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3389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9983F9E-6352-4ABF-9B1E-921690524F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11F44874-2355-4A05-8CA6-984388BE3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D50-781E-4BD3-9232-6C9BC43C6BC1}" type="datetimeFigureOut">
              <a:rPr lang="zh-CN" altLang="en-US" smtClean="0"/>
              <a:t>2021/10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1B23F5E7-3EAE-4810-9DE1-DDD8F3967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59086D1A-FF73-4A09-A547-09A1016F5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EA5D9-C73A-4035-87D2-EE4D85F732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8239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D3880744-5D03-4E91-903D-7956D27B2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D50-781E-4BD3-9232-6C9BC43C6BC1}" type="datetimeFigureOut">
              <a:rPr lang="zh-CN" altLang="en-US" smtClean="0"/>
              <a:t>2021/10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1DF9871F-0110-436D-9FDC-6C26728B8F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D32B4F50-B933-4802-91F7-809DFAA8D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EA5D9-C73A-4035-87D2-EE4D85F732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1136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A91234B8-25F2-441F-AE62-57EA09D4D2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D919D24D-F1BB-47E1-9AA2-2A13DD3818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52FA8FDB-6202-48EC-892D-21832707DC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F144CCB-F102-4D12-8C7B-DE30B347F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D50-781E-4BD3-9232-6C9BC43C6BC1}" type="datetimeFigureOut">
              <a:rPr lang="zh-CN" altLang="en-US" smtClean="0"/>
              <a:t>2021/10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99F0BC5B-75FF-4B3E-BC1B-ABA9DEFE8E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9D44BA76-AB5E-4F7C-BE6A-806A30FA30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EA5D9-C73A-4035-87D2-EE4D85F732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8265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1A1159E9-0FE6-48DA-9127-5A89EE7810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9E37A4E6-A7AD-47D0-9861-BCCD51401C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7426F36A-3B3F-4B28-8730-77346AC6D0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B7F828E5-378B-4C64-BD30-5AC40B25CB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69D50-781E-4BD3-9232-6C9BC43C6BC1}" type="datetimeFigureOut">
              <a:rPr lang="zh-CN" altLang="en-US" smtClean="0"/>
              <a:t>2021/10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7BF6A908-BF14-4598-A7FA-3E703BCD2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68C1535B-0182-4D93-9CA8-D74031D2C4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EA5D9-C73A-4035-87D2-EE4D85F732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8648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49302161-2620-4254-8100-FD4DC9BE3B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F3E9DB68-A6B5-49DD-BCB8-962093FA67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0912A177-36D8-41DE-83F2-936A3DB301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F69D50-781E-4BD3-9232-6C9BC43C6BC1}" type="datetimeFigureOut">
              <a:rPr lang="zh-CN" altLang="en-US" smtClean="0"/>
              <a:t>2021/10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9599EA4-1E7C-48A1-B628-D6508E300C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E18294F2-A4B5-4E9F-A400-566648A151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EA5D9-C73A-4035-87D2-EE4D85F732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5138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D:\我的坚果云\我的坚果云\论文信息\褪黑素和枣疯病07.16\HR\论文图片\CK MeJA.tif">
            <a:extLst>
              <a:ext uri="{FF2B5EF4-FFF2-40B4-BE49-F238E27FC236}">
                <a16:creationId xmlns:a16="http://schemas.microsoft.com/office/drawing/2014/main" xmlns="" id="{0B3E76C7-4B71-4F96-9248-0192D41D6B6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91966" y="399875"/>
            <a:ext cx="3678474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D:\我的坚果云\我的坚果云\论文信息\褪黑素和枣疯病07.16\HR\论文图片\CK SA.jpg">
            <a:extLst>
              <a:ext uri="{FF2B5EF4-FFF2-40B4-BE49-F238E27FC236}">
                <a16:creationId xmlns:a16="http://schemas.microsoft.com/office/drawing/2014/main" xmlns="" id="{4F12C0F5-6D7D-4B7A-95D6-BAA8D01A386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9" r="5624" b="6231"/>
          <a:stretch/>
        </p:blipFill>
        <p:spPr bwMode="auto">
          <a:xfrm>
            <a:off x="4591966" y="2612696"/>
            <a:ext cx="3695700" cy="18230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4" descr="D:\我的坚果云\我的坚果云\论文信息\褪黑素和枣疯病07.16\HR\论文图片\CK IBU.jpg">
            <a:extLst>
              <a:ext uri="{FF2B5EF4-FFF2-40B4-BE49-F238E27FC236}">
                <a16:creationId xmlns:a16="http://schemas.microsoft.com/office/drawing/2014/main" xmlns="" id="{233322DE-09CC-4EF8-9518-5640239D618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5" t="5428" r="6965" b="7118"/>
          <a:stretch/>
        </p:blipFill>
        <p:spPr bwMode="auto">
          <a:xfrm>
            <a:off x="4591966" y="4894876"/>
            <a:ext cx="3924301" cy="1866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AEE5B2E0-5C93-4047-B904-42CA65A44D56}"/>
              </a:ext>
            </a:extLst>
          </p:cNvPr>
          <p:cNvSpPr txBox="1"/>
          <p:nvPr/>
        </p:nvSpPr>
        <p:spPr>
          <a:xfrm>
            <a:off x="6968230" y="-98823"/>
            <a:ext cx="110100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 err="1"/>
              <a:t>MeJA</a:t>
            </a:r>
            <a:endParaRPr lang="zh-CN" altLang="en-US" sz="3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A9B50D19-E886-4BA9-87C6-78B09835828B}"/>
              </a:ext>
            </a:extLst>
          </p:cNvPr>
          <p:cNvSpPr txBox="1"/>
          <p:nvPr/>
        </p:nvSpPr>
        <p:spPr>
          <a:xfrm>
            <a:off x="5024014" y="-104181"/>
            <a:ext cx="83708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/>
              <a:t>Con</a:t>
            </a:r>
            <a:endParaRPr lang="zh-CN" altLang="en-US" sz="3200" dirty="0"/>
          </a:p>
        </p:txBody>
      </p:sp>
      <p:sp>
        <p:nvSpPr>
          <p:cNvPr id="9" name="TextBox 10">
            <a:extLst>
              <a:ext uri="{FF2B5EF4-FFF2-40B4-BE49-F238E27FC236}">
                <a16:creationId xmlns:a16="http://schemas.microsoft.com/office/drawing/2014/main" xmlns="" id="{C43D8A9F-28DB-40C0-8EE8-28AE5A5EE41C}"/>
              </a:ext>
            </a:extLst>
          </p:cNvPr>
          <p:cNvSpPr txBox="1"/>
          <p:nvPr/>
        </p:nvSpPr>
        <p:spPr>
          <a:xfrm>
            <a:off x="7223320" y="2079935"/>
            <a:ext cx="60805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/>
              <a:t>SA</a:t>
            </a:r>
            <a:endParaRPr lang="zh-CN" altLang="en-US" sz="3200" dirty="0"/>
          </a:p>
        </p:txBody>
      </p:sp>
      <p:sp>
        <p:nvSpPr>
          <p:cNvPr id="10" name="TextBox 11">
            <a:extLst>
              <a:ext uri="{FF2B5EF4-FFF2-40B4-BE49-F238E27FC236}">
                <a16:creationId xmlns:a16="http://schemas.microsoft.com/office/drawing/2014/main" xmlns="" id="{C1763585-89E6-42FD-807A-E3C53A5DCC2F}"/>
              </a:ext>
            </a:extLst>
          </p:cNvPr>
          <p:cNvSpPr txBox="1"/>
          <p:nvPr/>
        </p:nvSpPr>
        <p:spPr>
          <a:xfrm>
            <a:off x="4960619" y="2104298"/>
            <a:ext cx="83708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/>
              <a:t>Con</a:t>
            </a:r>
            <a:endParaRPr lang="zh-CN" altLang="en-US" sz="3200" dirty="0"/>
          </a:p>
        </p:txBody>
      </p:sp>
      <p:sp>
        <p:nvSpPr>
          <p:cNvPr id="11" name="TextBox 12">
            <a:extLst>
              <a:ext uri="{FF2B5EF4-FFF2-40B4-BE49-F238E27FC236}">
                <a16:creationId xmlns:a16="http://schemas.microsoft.com/office/drawing/2014/main" xmlns="" id="{5BC5BFF7-FDD4-484F-B279-54558D5C1430}"/>
              </a:ext>
            </a:extLst>
          </p:cNvPr>
          <p:cNvSpPr txBox="1"/>
          <p:nvPr/>
        </p:nvSpPr>
        <p:spPr>
          <a:xfrm>
            <a:off x="7314221" y="4391266"/>
            <a:ext cx="7216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 err="1"/>
              <a:t>Ibu</a:t>
            </a:r>
            <a:endParaRPr lang="zh-CN" altLang="en-US" sz="3200" dirty="0"/>
          </a:p>
        </p:txBody>
      </p:sp>
      <p:sp>
        <p:nvSpPr>
          <p:cNvPr id="12" name="TextBox 13">
            <a:extLst>
              <a:ext uri="{FF2B5EF4-FFF2-40B4-BE49-F238E27FC236}">
                <a16:creationId xmlns:a16="http://schemas.microsoft.com/office/drawing/2014/main" xmlns="" id="{CCD1FC93-7048-41B4-9E0E-E6020E95E5EB}"/>
              </a:ext>
            </a:extLst>
          </p:cNvPr>
          <p:cNvSpPr txBox="1"/>
          <p:nvPr/>
        </p:nvSpPr>
        <p:spPr>
          <a:xfrm>
            <a:off x="4888611" y="4391267"/>
            <a:ext cx="83708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200" dirty="0"/>
              <a:t>Con</a:t>
            </a:r>
            <a:endParaRPr lang="zh-CN" altLang="en-US" sz="3200" dirty="0"/>
          </a:p>
        </p:txBody>
      </p:sp>
    </p:spTree>
    <p:extLst>
      <p:ext uri="{BB962C8B-B14F-4D97-AF65-F5344CB8AC3E}">
        <p14:creationId xmlns:p14="http://schemas.microsoft.com/office/powerpoint/2010/main" val="7969369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xmlns="" id="{69DF3EDA-9CC8-4CAE-961E-39C9C209A4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981200" y="1140191"/>
            <a:ext cx="8229600" cy="2214764"/>
          </a:xfrm>
        </p:spPr>
        <p:txBody>
          <a:bodyPr>
            <a:noAutofit/>
          </a:bodyPr>
          <a:lstStyle/>
          <a:p>
            <a:pPr algn="just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. S1 The phenotype of JWB symptom in tissue culture DH2 after </a:t>
            </a:r>
            <a:r>
              <a:rPr lang="el-GR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100 μ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MeJA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,</a:t>
            </a:r>
            <a:r>
              <a: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A and ibuprofen treatment for one month, </a:t>
            </a:r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respectivley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b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1558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4</Words>
  <Application>Microsoft Office PowerPoint</Application>
  <PresentationFormat>自定义</PresentationFormat>
  <Paragraphs>7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​​</vt:lpstr>
      <vt:lpstr>PowerPoint 演示文稿</vt:lpstr>
      <vt:lpstr>Fig. S1 The phenotype of JWB symptom in tissue culture DH2 after 100 μM MeJA , SA and ibuprofen treatment for one month, respectivley.  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User</cp:lastModifiedBy>
  <cp:revision>2</cp:revision>
  <dcterms:created xsi:type="dcterms:W3CDTF">2021-07-23T07:57:07Z</dcterms:created>
  <dcterms:modified xsi:type="dcterms:W3CDTF">2021-10-14T06:09:40Z</dcterms:modified>
</cp:coreProperties>
</file>